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64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>
      <p:cViewPr>
        <p:scale>
          <a:sx n="70" d="100"/>
          <a:sy n="70" d="100"/>
        </p:scale>
        <p:origin x="1180" y="-2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1/09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1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463474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oedecke</a:t>
            </a:r>
            <a:r>
              <a:rPr lang="en-GB" dirty="0"/>
              <a:t> and Mendham (2022) Diabetologia DOI 10.1007/s00125-022-05795-2 </a:t>
            </a:r>
            <a:endParaRPr lang="en-GB" sz="1200" dirty="0">
              <a:highlight>
                <a:srgbClr val="00FF00"/>
              </a:highlight>
            </a:endParaRP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onventional paradigm of type 2 diabetes (a) compared with findings from studies of Black Africans from sub-Saharan Africa (b)</a:t>
            </a:r>
            <a:endParaRPr lang="en-GB" sz="20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82AAEA7-29BA-F5BB-FFA4-505F399D2C7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192" y="1526826"/>
            <a:ext cx="8474280" cy="3923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589240"/>
            <a:ext cx="7704856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Goedecke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and Mendham (2022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2-05795-2 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highlight>
                <a:srgbClr val="00FF00"/>
              </a:highlight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2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ROC curves of basal insulin secretion and clearance to predict </a:t>
            </a:r>
            <a:r>
              <a:rPr lang="en-US" sz="2000" b="1" dirty="0" err="1"/>
              <a:t>dysglycaemia</a:t>
            </a:r>
            <a:r>
              <a:rPr lang="en-US" sz="2000" b="1" dirty="0"/>
              <a:t> in middle-aged Black South African women 1.5 years later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24A219A-69FE-C64C-AB1E-D4CE17BBA2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8894" y="1360928"/>
            <a:ext cx="7130319" cy="4359396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589240"/>
            <a:ext cx="7704856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Goedecke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and Mendham (2022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2-05795-2 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highlight>
                <a:srgbClr val="00FF00"/>
              </a:highlight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2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Response to a 12 week combined aerobic and resistance exercise training intervention in Black South African women with obesity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AACCC67-E81C-72DE-1ED2-9EC2750639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16759" y="1077019"/>
            <a:ext cx="5935561" cy="4569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20026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517232"/>
            <a:ext cx="7704856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Goedecke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and Mendham (2022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2-05795-2 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highlight>
                <a:srgbClr val="00FF00"/>
              </a:highlight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2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Model of the pathogenesis of type 2 diabetes in sub-Saharan African population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EB4AE99-1EDD-2A73-71B3-52F130D482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5696" y="921856"/>
            <a:ext cx="5256584" cy="46673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0584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5</Words>
  <Application>Microsoft Office PowerPoint</Application>
  <PresentationFormat>On-screen Show (4:3)</PresentationFormat>
  <Paragraphs>17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3</cp:revision>
  <dcterms:created xsi:type="dcterms:W3CDTF">2016-06-15T12:53:43Z</dcterms:created>
  <dcterms:modified xsi:type="dcterms:W3CDTF">2022-09-21T09:07:02Z</dcterms:modified>
</cp:coreProperties>
</file>